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omments/modernComment_107_950B8AEF.xml" ContentType="application/vnd.ms-powerpoint.comments+xml"/>
  <Override PartName="/ppt/comments/modernComment_10A_9B6F670E.xml" ContentType="application/vnd.ms-powerpoint.comments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7"/>
  </p:notesMasterIdLst>
  <p:sldIdLst>
    <p:sldId id="257" r:id="rId2"/>
    <p:sldId id="265" r:id="rId3"/>
    <p:sldId id="263" r:id="rId4"/>
    <p:sldId id="267" r:id="rId5"/>
    <p:sldId id="266" r:id="rId6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4CAEA62A-25F6-81A0-2751-708BEEFCA93B}" name="Thomas Premeaux" initials="TP" userId="S::tap4002@med.cornell.edu::d3d1a55c-39f5-451b-90b3-4e1664303b1f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BC89EF96-8CEA-46FF-86C4-4CE0E7609802}" styleName="Light Style 3 - Acc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981"/>
    <p:restoredTop sz="96327"/>
  </p:normalViewPr>
  <p:slideViewPr>
    <p:cSldViewPr snapToGrid="0">
      <p:cViewPr varScale="1">
        <p:scale>
          <a:sx n="86" d="100"/>
          <a:sy n="86" d="100"/>
        </p:scale>
        <p:origin x="344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omments/modernComment_107_950B8AEF.xml><?xml version="1.0" encoding="utf-8"?>
<p188:cmLst xmlns:a="http://schemas.openxmlformats.org/drawingml/2006/main" xmlns:r="http://schemas.openxmlformats.org/officeDocument/2006/relationships" xmlns:p188="http://schemas.microsoft.com/office/powerpoint/2018/8/main">
  <p188:cm id="{9FB6EAB4-1112-324F-BB16-66C9F7D9568D}" authorId="{4CAEA62A-25F6-81A0-2751-708BEEFCA93B}" created="2024-07-30T16:15:30.658">
    <ac:deMkLst xmlns:ac="http://schemas.microsoft.com/office/drawing/2013/main/command">
      <pc:docMk xmlns:pc="http://schemas.microsoft.com/office/powerpoint/2013/main/command"/>
      <pc:sldMk xmlns:pc="http://schemas.microsoft.com/office/powerpoint/2013/main/command" cId="2500561647" sldId="263"/>
      <ac:graphicFrameMk id="2" creationId="{4F619B59-EFEF-CE91-A6CB-C742C30754DA}"/>
    </ac:deMkLst>
    <p188:pos x="4033712" y="3917699"/>
    <p188:txBody>
      <a:bodyPr/>
      <a:lstStyle/>
      <a:p>
        <a:r>
          <a:rPr lang="en-US"/>
          <a:t>Need to include</a:t>
        </a:r>
      </a:p>
    </p188:txBody>
  </p188:cm>
</p188:cmLst>
</file>

<file path=ppt/comments/modernComment_10A_9B6F670E.xml><?xml version="1.0" encoding="utf-8"?>
<p188:cmLst xmlns:a="http://schemas.openxmlformats.org/drawingml/2006/main" xmlns:r="http://schemas.openxmlformats.org/officeDocument/2006/relationships" xmlns:p188="http://schemas.microsoft.com/office/powerpoint/2018/8/main">
  <p188:cm id="{27DB4FEB-C690-D94B-A7A1-0D20CEA44CF2}" authorId="{4CAEA62A-25F6-81A0-2751-708BEEFCA93B}" created="2024-07-30T16:15:47.930">
    <ac:txMkLst xmlns:ac="http://schemas.microsoft.com/office/drawing/2013/main/command">
      <pc:docMk xmlns:pc="http://schemas.microsoft.com/office/powerpoint/2013/main/command"/>
      <pc:sldMk xmlns:pc="http://schemas.microsoft.com/office/powerpoint/2013/main/command" cId="2607769358" sldId="266"/>
      <ac:graphicFrameMk id="11" creationId="{BA75FE49-1CE8-936C-D6D8-00699325AC82}"/>
      <ac:tblMk/>
      <ac:tcMk rowId="738775878" colId="2898020489"/>
      <ac:txMk cp="0" len="5">
        <ac:context len="6" hash="3333108121"/>
      </ac:txMk>
    </ac:txMkLst>
    <p188:pos x="5747938" y="575099"/>
    <p188:txBody>
      <a:bodyPr/>
      <a:lstStyle/>
      <a:p>
        <a:r>
          <a:rPr lang="en-US"/>
          <a:t>Need to confirm</a:t>
        </a:r>
      </a:p>
    </p188:txBody>
  </p188:cm>
</p188:cmLst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9E6DA7-3A25-B14C-A658-FD677F185455}" type="datetimeFigureOut">
              <a:rPr lang="en-US" smtClean="0"/>
              <a:t>9/5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624995-FDCB-3E4C-9810-F3EC8777DD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14556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28600" indent="-228600">
              <a:buAutoNum type="alphaUcParenR"/>
            </a:pPr>
            <a:r>
              <a:rPr lang="en-US" dirty="0"/>
              <a:t>Gating strategy for pDC and mDC populations after Total DC isolation</a:t>
            </a:r>
          </a:p>
          <a:p>
            <a:pPr marL="228600" indent="-228600">
              <a:buAutoNum type="alphaUcParenR"/>
            </a:pPr>
            <a:r>
              <a:rPr lang="en-US" dirty="0"/>
              <a:t>Maturation profile after LPS treatment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0624995-FDCB-3E4C-9810-F3EC8777DD1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3956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61DA2-F6D3-4F4C-8363-4C6AA04F611C}" type="datetimeFigureOut">
              <a:rPr lang="en-US" smtClean="0"/>
              <a:t>9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7E146-5CDB-B840-9D7B-A48982142C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17874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61DA2-F6D3-4F4C-8363-4C6AA04F611C}" type="datetimeFigureOut">
              <a:rPr lang="en-US" smtClean="0"/>
              <a:t>9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7E146-5CDB-B840-9D7B-A48982142C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4714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61DA2-F6D3-4F4C-8363-4C6AA04F611C}" type="datetimeFigureOut">
              <a:rPr lang="en-US" smtClean="0"/>
              <a:t>9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7E146-5CDB-B840-9D7B-A48982142C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88442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61DA2-F6D3-4F4C-8363-4C6AA04F611C}" type="datetimeFigureOut">
              <a:rPr lang="en-US" smtClean="0"/>
              <a:t>9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7E146-5CDB-B840-9D7B-A48982142C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26906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61DA2-F6D3-4F4C-8363-4C6AA04F611C}" type="datetimeFigureOut">
              <a:rPr lang="en-US" smtClean="0"/>
              <a:t>9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7E146-5CDB-B840-9D7B-A48982142C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62263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61DA2-F6D3-4F4C-8363-4C6AA04F611C}" type="datetimeFigureOut">
              <a:rPr lang="en-US" smtClean="0"/>
              <a:t>9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7E146-5CDB-B840-9D7B-A48982142C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1726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61DA2-F6D3-4F4C-8363-4C6AA04F611C}" type="datetimeFigureOut">
              <a:rPr lang="en-US" smtClean="0"/>
              <a:t>9/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7E146-5CDB-B840-9D7B-A48982142C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61395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61DA2-F6D3-4F4C-8363-4C6AA04F611C}" type="datetimeFigureOut">
              <a:rPr lang="en-US" smtClean="0"/>
              <a:t>9/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7E146-5CDB-B840-9D7B-A48982142C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6478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61DA2-F6D3-4F4C-8363-4C6AA04F611C}" type="datetimeFigureOut">
              <a:rPr lang="en-US" smtClean="0"/>
              <a:t>9/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7E146-5CDB-B840-9D7B-A48982142C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19911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61DA2-F6D3-4F4C-8363-4C6AA04F611C}" type="datetimeFigureOut">
              <a:rPr lang="en-US" smtClean="0"/>
              <a:t>9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7E146-5CDB-B840-9D7B-A48982142C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5239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61DA2-F6D3-4F4C-8363-4C6AA04F611C}" type="datetimeFigureOut">
              <a:rPr lang="en-US" smtClean="0"/>
              <a:t>9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7E146-5CDB-B840-9D7B-A48982142C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1554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361DA2-F6D3-4F4C-8363-4C6AA04F611C}" type="datetimeFigureOut">
              <a:rPr lang="en-US" smtClean="0"/>
              <a:t>9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67E146-5CDB-B840-9D7B-A48982142C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35278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2" Type="http://schemas.microsoft.com/office/2018/10/relationships/comments" Target="../comments/modernComment_107_950B8AEF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microsoft.com/office/2018/10/relationships/comments" Target="../comments/modernComment_10A_9B6F670E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EB13387D-C4C1-CD9F-AC57-D6F6C4373B94}"/>
              </a:ext>
            </a:extLst>
          </p:cNvPr>
          <p:cNvSpPr/>
          <p:nvPr/>
        </p:nvSpPr>
        <p:spPr>
          <a:xfrm>
            <a:off x="713433" y="402383"/>
            <a:ext cx="1772993" cy="7938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5CB2D45-08C1-0DA7-BA32-57118DA8233F}"/>
              </a:ext>
            </a:extLst>
          </p:cNvPr>
          <p:cNvSpPr txBox="1"/>
          <p:nvPr/>
        </p:nvSpPr>
        <p:spPr>
          <a:xfrm>
            <a:off x="50801" y="1133"/>
            <a:ext cx="66868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E5419B9-64CD-39B9-E7F6-EEA09F393607}"/>
              </a:ext>
            </a:extLst>
          </p:cNvPr>
          <p:cNvSpPr txBox="1"/>
          <p:nvPr/>
        </p:nvSpPr>
        <p:spPr>
          <a:xfrm>
            <a:off x="362875" y="33564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4C9C281-2734-09E6-2145-B7BF046308EF}"/>
              </a:ext>
            </a:extLst>
          </p:cNvPr>
          <p:cNvSpPr txBox="1"/>
          <p:nvPr/>
        </p:nvSpPr>
        <p:spPr>
          <a:xfrm>
            <a:off x="362875" y="2130294"/>
            <a:ext cx="1572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FCF9728-8F85-B50E-BD5D-A077889BFB7E}"/>
              </a:ext>
            </a:extLst>
          </p:cNvPr>
          <p:cNvSpPr txBox="1"/>
          <p:nvPr/>
        </p:nvSpPr>
        <p:spPr>
          <a:xfrm>
            <a:off x="362875" y="447783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id="{6F0D0BE2-9073-A35A-908D-48901153046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7385" y="2225831"/>
            <a:ext cx="3691760" cy="2255540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603CACCF-A362-0C44-2D52-33625ED0BCA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04170" y="2225830"/>
            <a:ext cx="1248866" cy="2140195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62AEED06-ED32-E04B-EC91-6F5885EAD71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1016"/>
          <a:stretch/>
        </p:blipFill>
        <p:spPr>
          <a:xfrm>
            <a:off x="677385" y="4508475"/>
            <a:ext cx="4598993" cy="1833209"/>
          </a:xfrm>
          <a:prstGeom prst="rect">
            <a:avLst/>
          </a:prstGeom>
        </p:spPr>
      </p:pic>
      <p:pic>
        <p:nvPicPr>
          <p:cNvPr id="28" name="Picture 27" descr="A diagram of a cell line&#10;&#10;Description automatically generated">
            <a:extLst>
              <a:ext uri="{FF2B5EF4-FFF2-40B4-BE49-F238E27FC236}">
                <a16:creationId xmlns:a16="http://schemas.microsoft.com/office/drawing/2014/main" id="{A7E1113E-C119-C68A-D97B-02A2741FC1E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3248" y="391830"/>
            <a:ext cx="4462817" cy="18204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00843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DEFD3E9-09D2-C204-3D2E-8156AB998F98}"/>
              </a:ext>
            </a:extLst>
          </p:cNvPr>
          <p:cNvSpPr txBox="1"/>
          <p:nvPr/>
        </p:nvSpPr>
        <p:spPr>
          <a:xfrm>
            <a:off x="50801" y="187791"/>
            <a:ext cx="66868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A2ED890E-7830-9A72-9D38-B09331B1034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1436" y="1176012"/>
            <a:ext cx="2670532" cy="2207142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C5DCB017-809C-6401-7E3D-DD0F6FF3393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0343" y="4003082"/>
            <a:ext cx="2923619" cy="1446984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A0252A7-AC44-55DE-DA2B-11BEBECD5DE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0344" y="3312428"/>
            <a:ext cx="2923619" cy="802488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450272EB-68FF-A769-E0DA-9C7062CC6426}"/>
              </a:ext>
            </a:extLst>
          </p:cNvPr>
          <p:cNvSpPr txBox="1"/>
          <p:nvPr/>
        </p:nvSpPr>
        <p:spPr>
          <a:xfrm>
            <a:off x="199161" y="594583"/>
            <a:ext cx="319508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Comparison between Global HAM1 Exo and HAM1 control</a:t>
            </a:r>
          </a:p>
        </p:txBody>
      </p:sp>
      <p:sp>
        <p:nvSpPr>
          <p:cNvPr id="13" name="Title 3">
            <a:extLst>
              <a:ext uri="{FF2B5EF4-FFF2-40B4-BE49-F238E27FC236}">
                <a16:creationId xmlns:a16="http://schemas.microsoft.com/office/drawing/2014/main" id="{26F3142B-84B2-F79C-29C2-2A232BF1DCC0}"/>
              </a:ext>
            </a:extLst>
          </p:cNvPr>
          <p:cNvSpPr txBox="1"/>
          <p:nvPr/>
        </p:nvSpPr>
        <p:spPr>
          <a:xfrm>
            <a:off x="3652898" y="495568"/>
            <a:ext cx="3139126" cy="68044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>
              <a:lnSpc>
                <a:spcPct val="100000"/>
              </a:lnSpc>
            </a:pP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Comparison between Global HAM2 Exo and HAM2 control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8E27F511-BF27-A67E-EF96-C480C082CAA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26034" y="1110748"/>
            <a:ext cx="2658256" cy="2148519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E69C90E9-5935-5DA8-D72B-407B79577F1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47384" y="3312428"/>
            <a:ext cx="2915733" cy="9386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60586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C6CE0BCB-9D24-7B03-066A-826D9F16FFDB}"/>
              </a:ext>
            </a:extLst>
          </p:cNvPr>
          <p:cNvSpPr txBox="1"/>
          <p:nvPr/>
        </p:nvSpPr>
        <p:spPr>
          <a:xfrm>
            <a:off x="274283" y="470895"/>
            <a:ext cx="45670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1. Multicolor Flow Dendritic Cell Panel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4F619B59-EFEF-CE91-A6CB-C742C30754D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30738086"/>
              </p:ext>
            </p:extLst>
          </p:nvPr>
        </p:nvGraphicFramePr>
        <p:xfrm>
          <a:off x="338452" y="896526"/>
          <a:ext cx="5495925" cy="392303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066925">
                  <a:extLst>
                    <a:ext uri="{9D8B030D-6E8A-4147-A177-3AD203B41FA5}">
                      <a16:colId xmlns:a16="http://schemas.microsoft.com/office/drawing/2014/main" val="2980112447"/>
                    </a:ext>
                  </a:extLst>
                </a:gridCol>
                <a:gridCol w="1835785">
                  <a:extLst>
                    <a:ext uri="{9D8B030D-6E8A-4147-A177-3AD203B41FA5}">
                      <a16:colId xmlns:a16="http://schemas.microsoft.com/office/drawing/2014/main" val="246511790"/>
                    </a:ext>
                  </a:extLst>
                </a:gridCol>
                <a:gridCol w="1593215">
                  <a:extLst>
                    <a:ext uri="{9D8B030D-6E8A-4147-A177-3AD203B41FA5}">
                      <a16:colId xmlns:a16="http://schemas.microsoft.com/office/drawing/2014/main" val="400692054"/>
                    </a:ext>
                  </a:extLst>
                </a:gridCol>
              </a:tblGrid>
              <a:tr h="26924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</a:rPr>
                        <a:t>Target-Fluorophore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</a:rPr>
                        <a:t>Manufacturer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</a:rPr>
                        <a:t>Clone/Catalog#</a:t>
                      </a: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9933740"/>
                  </a:ext>
                </a:extLst>
              </a:tr>
              <a:tr h="26098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</a:rPr>
                        <a:t>L/D-</a:t>
                      </a:r>
                      <a:r>
                        <a:rPr lang="en-US" sz="1100" b="0" kern="100" dirty="0" err="1">
                          <a:solidFill>
                            <a:schemeClr val="tx1"/>
                          </a:solidFill>
                          <a:effectLst/>
                        </a:rPr>
                        <a:t>Amcyan</a:t>
                      </a:r>
                      <a:endParaRPr lang="en-US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</a:rPr>
                        <a:t>Invitrogen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4352002"/>
                  </a:ext>
                </a:extLst>
              </a:tr>
              <a:tr h="26098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</a:rPr>
                        <a:t>HLA-DR-A700</a:t>
                      </a:r>
                      <a:endParaRPr lang="en-US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" dirty="0" err="1">
                          <a:solidFill>
                            <a:schemeClr val="tx1"/>
                          </a:solidFill>
                          <a:effectLst/>
                        </a:rPr>
                        <a:t>BioLegend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92783918"/>
                  </a:ext>
                </a:extLst>
              </a:tr>
              <a:tr h="26098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</a:rPr>
                        <a:t>CD303-APC-Cy7</a:t>
                      </a:r>
                      <a:endParaRPr lang="en-US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" dirty="0" err="1">
                          <a:solidFill>
                            <a:schemeClr val="tx1"/>
                          </a:solidFill>
                          <a:effectLst/>
                        </a:rPr>
                        <a:t>BioLegend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30375187"/>
                  </a:ext>
                </a:extLst>
              </a:tr>
              <a:tr h="26098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</a:rPr>
                        <a:t>CD86-PerCp5.5</a:t>
                      </a:r>
                      <a:endParaRPr lang="en-US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</a:rPr>
                        <a:t>BD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64485997"/>
                  </a:ext>
                </a:extLst>
              </a:tr>
              <a:tr h="26098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</a:rPr>
                        <a:t>CD141-FITC</a:t>
                      </a:r>
                      <a:endParaRPr lang="en-US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" dirty="0" err="1">
                          <a:solidFill>
                            <a:schemeClr val="tx1"/>
                          </a:solidFill>
                          <a:effectLst/>
                        </a:rPr>
                        <a:t>Miltenyi</a:t>
                      </a: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sz="1100" kern="100" dirty="0" err="1">
                          <a:solidFill>
                            <a:schemeClr val="tx1"/>
                          </a:solidFill>
                          <a:effectLst/>
                        </a:rPr>
                        <a:t>Biotec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09778367"/>
                  </a:ext>
                </a:extLst>
              </a:tr>
              <a:tr h="26098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</a:rPr>
                        <a:t>CD1c-BV605</a:t>
                      </a:r>
                      <a:endParaRPr lang="en-US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" dirty="0" err="1">
                          <a:solidFill>
                            <a:schemeClr val="tx1"/>
                          </a:solidFill>
                          <a:effectLst/>
                        </a:rPr>
                        <a:t>BioLegend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64425831"/>
                  </a:ext>
                </a:extLst>
              </a:tr>
              <a:tr h="26098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</a:rPr>
                        <a:t>CD11c-BV650</a:t>
                      </a:r>
                      <a:endParaRPr lang="en-US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" dirty="0" err="1">
                          <a:solidFill>
                            <a:schemeClr val="tx1"/>
                          </a:solidFill>
                          <a:effectLst/>
                        </a:rPr>
                        <a:t>BioLegend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1250587"/>
                  </a:ext>
                </a:extLst>
              </a:tr>
              <a:tr h="26098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</a:rPr>
                        <a:t>DCIR2-BV711</a:t>
                      </a:r>
                      <a:endParaRPr lang="en-US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</a:rPr>
                        <a:t>BD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79648007"/>
                  </a:ext>
                </a:extLst>
              </a:tr>
              <a:tr h="26098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</a:rPr>
                        <a:t>41BBL-BV786</a:t>
                      </a:r>
                      <a:endParaRPr lang="en-US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</a:rPr>
                        <a:t>BD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81652495"/>
                  </a:ext>
                </a:extLst>
              </a:tr>
              <a:tr h="26098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</a:rPr>
                        <a:t>CD40-ECD</a:t>
                      </a:r>
                      <a:endParaRPr lang="en-US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" dirty="0" err="1">
                          <a:solidFill>
                            <a:schemeClr val="tx1"/>
                          </a:solidFill>
                          <a:effectLst/>
                        </a:rPr>
                        <a:t>BioLegend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5295378"/>
                  </a:ext>
                </a:extLst>
              </a:tr>
              <a:tr h="26098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</a:rPr>
                        <a:t>CD80-PECy5</a:t>
                      </a:r>
                      <a:endParaRPr lang="en-US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</a:rPr>
                        <a:t>BioLegend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8888713"/>
                  </a:ext>
                </a:extLst>
              </a:tr>
              <a:tr h="26098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</a:rPr>
                        <a:t>CD3-PECy7</a:t>
                      </a:r>
                      <a:endParaRPr lang="en-US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</a:rPr>
                        <a:t>BioLegend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55535865"/>
                  </a:ext>
                </a:extLst>
              </a:tr>
              <a:tr h="26098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</a:rPr>
                        <a:t>CD86-BUV395</a:t>
                      </a:r>
                      <a:endParaRPr lang="en-US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</a:rPr>
                        <a:t>BD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18215974"/>
                  </a:ext>
                </a:extLst>
              </a:tr>
              <a:tr h="26098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</a:rPr>
                        <a:t>CD16-BUV737</a:t>
                      </a:r>
                      <a:endParaRPr lang="en-US" sz="12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</a:rPr>
                        <a:t>BD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4149051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00561647"/>
      </p:ext>
    </p:extLst>
  </p:cSld>
  <p:clrMapOvr>
    <a:masterClrMapping/>
  </p:clrMapOvr>
  <p:extLst>
    <p:ext uri="{6950BFC3-D8DA-4A85-94F7-54DA5524770B}">
      <p188:commentRel xmlns:p188="http://schemas.microsoft.com/office/powerpoint/2018/8/main" r:id="rId2"/>
    </p:ext>
  </p:extLst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C6CE0BCB-9D24-7B03-066A-826D9F16FFDB}"/>
              </a:ext>
            </a:extLst>
          </p:cNvPr>
          <p:cNvSpPr txBox="1"/>
          <p:nvPr/>
        </p:nvSpPr>
        <p:spPr>
          <a:xfrm>
            <a:off x="274283" y="470895"/>
            <a:ext cx="49678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2. Multicolor Flow CD4 and CD8 T Cell Panel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54572DA2-F87E-CFA7-7F02-E1D3C627DEF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54050722"/>
              </p:ext>
            </p:extLst>
          </p:nvPr>
        </p:nvGraphicFramePr>
        <p:xfrm>
          <a:off x="375449" y="871286"/>
          <a:ext cx="5535747" cy="5802310"/>
        </p:xfrm>
        <a:graphic>
          <a:graphicData uri="http://schemas.openxmlformats.org/drawingml/2006/table">
            <a:tbl>
              <a:tblPr firstRow="1" firstCol="1" bandRow="1"/>
              <a:tblGrid>
                <a:gridCol w="1862815">
                  <a:extLst>
                    <a:ext uri="{9D8B030D-6E8A-4147-A177-3AD203B41FA5}">
                      <a16:colId xmlns:a16="http://schemas.microsoft.com/office/drawing/2014/main" val="3403030459"/>
                    </a:ext>
                  </a:extLst>
                </a:gridCol>
                <a:gridCol w="1836466">
                  <a:extLst>
                    <a:ext uri="{9D8B030D-6E8A-4147-A177-3AD203B41FA5}">
                      <a16:colId xmlns:a16="http://schemas.microsoft.com/office/drawing/2014/main" val="3144249063"/>
                    </a:ext>
                  </a:extLst>
                </a:gridCol>
                <a:gridCol w="1836466">
                  <a:extLst>
                    <a:ext uri="{9D8B030D-6E8A-4147-A177-3AD203B41FA5}">
                      <a16:colId xmlns:a16="http://schemas.microsoft.com/office/drawing/2014/main" val="3085552870"/>
                    </a:ext>
                  </a:extLst>
                </a:gridCol>
              </a:tblGrid>
              <a:tr h="263744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Target-Fluorophore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C9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Manufacturer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C9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lone/Catalog#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C9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96790608"/>
                  </a:ext>
                </a:extLst>
              </a:tr>
              <a:tr h="263744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PD-1-PE</a:t>
                      </a:r>
                      <a:endParaRPr lang="en-US" sz="11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BioLegend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EH122H7, 329906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5863397"/>
                  </a:ext>
                </a:extLst>
              </a:tr>
              <a:tr h="263744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D8-AF700</a:t>
                      </a:r>
                      <a:endParaRPr lang="en-US" sz="11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BD Pharmingen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RPA-78, 55794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8736930"/>
                  </a:ext>
                </a:extLst>
              </a:tr>
              <a:tr h="263744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D3-V450</a:t>
                      </a:r>
                      <a:endParaRPr lang="en-US" sz="11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BD Horizons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SP34-2, 560351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0854749"/>
                  </a:ext>
                </a:extLst>
              </a:tr>
              <a:tr h="263744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D4-PerCP/Cy5.5</a:t>
                      </a:r>
                      <a:endParaRPr lang="en-US" sz="11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BD Pharmingen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552838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3988329"/>
                  </a:ext>
                </a:extLst>
              </a:tr>
              <a:tr h="263744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D3-V450</a:t>
                      </a:r>
                      <a:endParaRPr lang="en-US" sz="11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BD Horizons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SP34-2, 560351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88740143"/>
                  </a:ext>
                </a:extLst>
              </a:tr>
              <a:tr h="263744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D4-PerCP/Cy5.5</a:t>
                      </a:r>
                      <a:endParaRPr lang="en-US" sz="1100" b="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BD Pharmingen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552838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304996"/>
                  </a:ext>
                </a:extLst>
              </a:tr>
              <a:tr h="263686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IFN</a:t>
                      </a:r>
                      <a:r>
                        <a:rPr lang="en-US" sz="10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sym typeface="Symbol" pitchFamily="2" charset="2"/>
                        </a:rPr>
                        <a:t></a:t>
                      </a:r>
                      <a:r>
                        <a:rPr lang="en-US" sz="10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-AF700</a:t>
                      </a:r>
                      <a:endParaRPr lang="en-US" sz="11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BD Pharmingen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557995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2936197"/>
                  </a:ext>
                </a:extLst>
              </a:tr>
              <a:tr h="263744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D8-AF700</a:t>
                      </a:r>
                      <a:endParaRPr lang="en-US" sz="11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BD Pharmingen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RPA-78, 55794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0001525"/>
                  </a:ext>
                </a:extLst>
              </a:tr>
              <a:tr h="263744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PD-1-FITC</a:t>
                      </a:r>
                      <a:endParaRPr lang="en-US" sz="11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BioLegend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EH12.2H7/329903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9840840"/>
                  </a:ext>
                </a:extLst>
              </a:tr>
              <a:tr h="263744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MIP-1a -PE</a:t>
                      </a:r>
                      <a:endParaRPr lang="en-US" sz="11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R&amp;D systems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93342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80587203"/>
                  </a:ext>
                </a:extLst>
              </a:tr>
              <a:tr h="263744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Perforin - FITC</a:t>
                      </a:r>
                      <a:endParaRPr lang="en-US" sz="11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Tepnel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B-D48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8898410"/>
                  </a:ext>
                </a:extLst>
              </a:tr>
              <a:tr h="263744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kern="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TNFa</a:t>
                      </a:r>
                      <a:r>
                        <a:rPr lang="en-US" sz="10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 – PE-Cy7</a:t>
                      </a:r>
                      <a:endParaRPr lang="en-US" sz="11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BD Pharmingen</a:t>
                      </a:r>
                      <a:endParaRPr lang="en-US" sz="11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Mab-11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4574387"/>
                  </a:ext>
                </a:extLst>
              </a:tr>
              <a:tr h="263744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D107a- APC</a:t>
                      </a:r>
                      <a:endParaRPr lang="en-US" sz="11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eBioScience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e-BIOH4A3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75979793"/>
                  </a:ext>
                </a:extLst>
              </a:tr>
              <a:tr h="263744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D4-PB</a:t>
                      </a:r>
                      <a:endParaRPr lang="en-US" sz="11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BioLegend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OKT4, 317423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3867116"/>
                  </a:ext>
                </a:extLst>
              </a:tr>
              <a:tr h="263744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CR5 -PE</a:t>
                      </a:r>
                      <a:endParaRPr lang="en-US" sz="11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BioLegend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J418F1, 359105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8821705"/>
                  </a:ext>
                </a:extLst>
              </a:tr>
              <a:tr h="263744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IL-4-APC</a:t>
                      </a:r>
                      <a:endParaRPr lang="en-US" sz="11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BioLegend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MP4-25D2,500811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1182825"/>
                  </a:ext>
                </a:extLst>
              </a:tr>
              <a:tr h="263744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CR4-V605</a:t>
                      </a:r>
                      <a:endParaRPr lang="en-US" sz="11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BioLegend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L291H4, 359417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6716139"/>
                  </a:ext>
                </a:extLst>
              </a:tr>
              <a:tr h="263744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IL-17a- APC-cy7</a:t>
                      </a:r>
                      <a:endParaRPr lang="en-US" sz="11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BioLegend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BL168,512319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3764578"/>
                  </a:ext>
                </a:extLst>
              </a:tr>
              <a:tr h="263744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CR6-BV711</a:t>
                      </a:r>
                      <a:endParaRPr lang="en-US" sz="11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BioLegend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G034E3, 353435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488389"/>
                  </a:ext>
                </a:extLst>
              </a:tr>
              <a:tr h="263744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D25-PE/Cy5</a:t>
                      </a:r>
                      <a:endParaRPr lang="en-US" sz="11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BioLegend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BC96, 302607</a:t>
                      </a:r>
                      <a:endParaRPr lang="en-US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0473678"/>
                  </a:ext>
                </a:extLst>
              </a:tr>
              <a:tr h="263744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FOXP3-FITC</a:t>
                      </a:r>
                      <a:endParaRPr lang="en-US" sz="11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BioLegend</a:t>
                      </a:r>
                      <a:endParaRPr lang="en-US" sz="11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06D, 320105</a:t>
                      </a:r>
                      <a:endParaRPr lang="en-US" sz="11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3638" marR="63638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694913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737922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C6CE0BCB-9D24-7B03-066A-826D9F16FFDB}"/>
              </a:ext>
            </a:extLst>
          </p:cNvPr>
          <p:cNvSpPr txBox="1"/>
          <p:nvPr/>
        </p:nvSpPr>
        <p:spPr>
          <a:xfrm>
            <a:off x="274283" y="470895"/>
            <a:ext cx="4074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3. Patient cohort demographics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BA75FE49-1CE8-936C-D6D8-00699325AC82}"/>
              </a:ext>
            </a:extLst>
          </p:cNvPr>
          <p:cNvGraphicFramePr>
            <a:graphicFrameLocks noGrp="1"/>
          </p:cNvGraphicFramePr>
          <p:nvPr/>
        </p:nvGraphicFramePr>
        <p:xfrm>
          <a:off x="404581" y="1023587"/>
          <a:ext cx="5915026" cy="2311510"/>
        </p:xfrm>
        <a:graphic>
          <a:graphicData uri="http://schemas.openxmlformats.org/drawingml/2006/table">
            <a:tbl>
              <a:tblPr/>
              <a:tblGrid>
                <a:gridCol w="713741">
                  <a:extLst>
                    <a:ext uri="{9D8B030D-6E8A-4147-A177-3AD203B41FA5}">
                      <a16:colId xmlns:a16="http://schemas.microsoft.com/office/drawing/2014/main" val="977606203"/>
                    </a:ext>
                  </a:extLst>
                </a:gridCol>
                <a:gridCol w="713741">
                  <a:extLst>
                    <a:ext uri="{9D8B030D-6E8A-4147-A177-3AD203B41FA5}">
                      <a16:colId xmlns:a16="http://schemas.microsoft.com/office/drawing/2014/main" val="2118262791"/>
                    </a:ext>
                  </a:extLst>
                </a:gridCol>
                <a:gridCol w="713741">
                  <a:extLst>
                    <a:ext uri="{9D8B030D-6E8A-4147-A177-3AD203B41FA5}">
                      <a16:colId xmlns:a16="http://schemas.microsoft.com/office/drawing/2014/main" val="48480222"/>
                    </a:ext>
                  </a:extLst>
                </a:gridCol>
                <a:gridCol w="713741">
                  <a:extLst>
                    <a:ext uri="{9D8B030D-6E8A-4147-A177-3AD203B41FA5}">
                      <a16:colId xmlns:a16="http://schemas.microsoft.com/office/drawing/2014/main" val="2584189371"/>
                    </a:ext>
                  </a:extLst>
                </a:gridCol>
                <a:gridCol w="583909">
                  <a:extLst>
                    <a:ext uri="{9D8B030D-6E8A-4147-A177-3AD203B41FA5}">
                      <a16:colId xmlns:a16="http://schemas.microsoft.com/office/drawing/2014/main" val="646441148"/>
                    </a:ext>
                  </a:extLst>
                </a:gridCol>
                <a:gridCol w="691375">
                  <a:extLst>
                    <a:ext uri="{9D8B030D-6E8A-4147-A177-3AD203B41FA5}">
                      <a16:colId xmlns:a16="http://schemas.microsoft.com/office/drawing/2014/main" val="3338295732"/>
                    </a:ext>
                  </a:extLst>
                </a:gridCol>
                <a:gridCol w="854927">
                  <a:extLst>
                    <a:ext uri="{9D8B030D-6E8A-4147-A177-3AD203B41FA5}">
                      <a16:colId xmlns:a16="http://schemas.microsoft.com/office/drawing/2014/main" val="3037683081"/>
                    </a:ext>
                  </a:extLst>
                </a:gridCol>
                <a:gridCol w="929851">
                  <a:extLst>
                    <a:ext uri="{9D8B030D-6E8A-4147-A177-3AD203B41FA5}">
                      <a16:colId xmlns:a16="http://schemas.microsoft.com/office/drawing/2014/main" val="2898020489"/>
                    </a:ext>
                  </a:extLst>
                </a:gridCol>
              </a:tblGrid>
              <a:tr h="34019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ample ID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4C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TLV type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4C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ace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4C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ge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4C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x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4C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isease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4C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VL/million PBMCs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4C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ample Type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4C7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58012964"/>
                  </a:ext>
                </a:extLst>
              </a:tr>
              <a:tr h="18655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499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 I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hite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C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t available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RUM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38775878"/>
                  </a:ext>
                </a:extLst>
              </a:tr>
              <a:tr h="17558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31195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 I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hite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AM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3869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RUM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8092522"/>
                  </a:ext>
                </a:extLst>
              </a:tr>
              <a:tr h="17558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31349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 I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lack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9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AM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t available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RUM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1661169"/>
                  </a:ext>
                </a:extLst>
              </a:tr>
              <a:tr h="17558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306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 I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hite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AM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3869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BMC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87151583"/>
                  </a:ext>
                </a:extLst>
              </a:tr>
              <a:tr h="17558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3651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 I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ispanic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1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AM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2604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BMC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2191805"/>
                  </a:ext>
                </a:extLst>
              </a:tr>
              <a:tr h="17558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35278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 I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sian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AM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254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RUM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59426106"/>
                  </a:ext>
                </a:extLst>
              </a:tr>
              <a:tr h="17558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477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 I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lack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AM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322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BMC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6472775"/>
                  </a:ext>
                </a:extLst>
              </a:tr>
              <a:tr h="17558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33392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 II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hite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C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3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RUM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6977542"/>
                  </a:ext>
                </a:extLst>
              </a:tr>
              <a:tr h="17558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14382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 II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hite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AM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3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RUM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4218069"/>
                  </a:ext>
                </a:extLst>
              </a:tr>
              <a:tr h="20449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28253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 II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ispanic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AM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t detectable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RUM/PBMC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73997332"/>
                  </a:ext>
                </a:extLst>
              </a:tr>
              <a:tr h="17558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33053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 II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hite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AM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40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RUM</a:t>
                      </a:r>
                    </a:p>
                  </a:txBody>
                  <a:tcPr marL="8231" marR="8231" marT="8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418066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07769358"/>
      </p:ext>
    </p:extLst>
  </p:cSld>
  <p:clrMapOvr>
    <a:masterClrMapping/>
  </p:clrMapOvr>
  <p:extLst>
    <p:ext uri="{6950BFC3-D8DA-4A85-94F7-54DA5524770B}">
      <p188:commentRel xmlns:p188="http://schemas.microsoft.com/office/powerpoint/2018/8/main" r:id="rId2"/>
    </p:ext>
  </p:extLst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53222</TotalTime>
  <Words>346</Words>
  <Application>Microsoft Office PowerPoint</Application>
  <PresentationFormat>Letter Paper (8.5x11 in)</PresentationFormat>
  <Paragraphs>206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ptos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seph,Julie</dc:creator>
  <cp:lastModifiedBy>MDPI</cp:lastModifiedBy>
  <cp:revision>50</cp:revision>
  <dcterms:created xsi:type="dcterms:W3CDTF">2023-12-06T15:44:21Z</dcterms:created>
  <dcterms:modified xsi:type="dcterms:W3CDTF">2024-09-05T01:50:42Z</dcterms:modified>
</cp:coreProperties>
</file>